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7" r:id="rId4"/>
    <p:sldId id="258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66" d="100"/>
          <a:sy n="66" d="100"/>
        </p:scale>
        <p:origin x="1210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5D44C1-46A9-40D5-BD06-0E1C954AC6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5F62674-43B7-4ACF-A5EF-CDF3E78E74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9DA8D5C-92F8-4735-A0EE-22CD45FAC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C9EC0CA-0F52-47F7-9DD1-B07D8CCBE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D49F922-AA7F-4834-A88C-F8296CDEA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9672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494B09A-0625-4399-AB62-2037D2D4C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3750D0-616F-4847-885C-42FC0DC168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0BD5DFE-6FF7-437E-BD56-6A11E97E6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2F6806-AA5F-4BC5-9C53-438E5701E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3C5A50-FC3F-454E-87D7-4ED10E87F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0419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2871771-ADE4-471E-A52D-271B934183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9FCF0A-7075-4275-BFF1-750FD10B25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4C25772-7DEF-4FDC-A7F1-EB4773D70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88E750F-0FFA-40EC-956F-E64B5A487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9745C5-9D5D-4565-B4AE-E2CEB741F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3080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29B534-4FE6-420C-A977-59FCA1BEF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BA84563-29A4-40EC-A279-EA5224A611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655857-503C-4956-9683-675CC5A43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44E5969-85E8-4D78-AA14-6C6BD421C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3851630-6008-4B53-BBEA-17355C164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1958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A1CC6C-39EB-431E-9479-BE3DD35C19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AB59AE1-5360-413B-B573-7809AC5AC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BAF43D6-6FFE-41A7-AC8F-E63E32ADD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3B07FCE-B135-4DF9-8A37-82731125A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6C269E-D249-4BCE-85C3-E3C610406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7640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983DF38-A2B3-4BB8-8235-57089F3DF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5FB350-03E1-4131-88D1-8E54FA656E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C1550B6-3F25-4FDA-834E-8FB1ED4D5D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4FBED81-64EE-47DB-8814-835065BFA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FC7F16B-5BF2-4CC0-868F-3F822803A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F65EF70-04F3-444C-92EB-B098E7C88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0343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3995BDC-3D6B-4845-BD06-2184FA115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7C5E68-7777-4F04-B102-EDE5F7F72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4DDE221-6F4D-4718-AFD7-43BB84F789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850BDC9-023C-4735-BF9A-71C6AD843B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7511A49-A204-4797-9683-75CF5A924D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4240DAF-A7A2-4A17-89DD-53304DC43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1F2C2EF-849B-4A6C-A348-C8B286D68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F3EB4BE-D830-4718-8C89-B8229DF65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1160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469FA3-A49A-4369-9E15-760BF0A0E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52264B0-745C-4F78-B04B-5077C2E0C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930F73A-32FE-4912-B170-15DE737E7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BC6A4E9-40D0-428B-914D-8D6C19933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4717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5DF53F2-C96B-4A1C-8562-719E67C9B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17BBC96-E44A-4672-B974-B597AB961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DAD0AD-BF80-4368-A376-953CDA857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8418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FDE94E-816C-491A-9FC1-BBE9913E3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F29707-033F-48C6-BDB3-557A809741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A214B1E-D1C2-4C85-87D5-89DFA5304E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7CE2285-D324-4142-9CAC-5CEA48115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346D589-1DB5-4A36-BCA1-11C9C0C4C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34EFF0-EDD3-4615-ADAB-40EC6B911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577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C455DF-9AA3-4E58-9AAA-C9BB22BB8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A271491-512B-4827-BF61-94848D5689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E6CADD9-70E9-44A2-AA8F-1D925E9763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B443078-6E94-4971-9DD3-16FD4872D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DB6F943-DE61-401E-931B-CDDB57058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17F6C38-ADF5-4E07-83EB-C5B9B025B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227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248B092-8738-4223-9E53-6C0C2743A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1C8BFF-648B-4120-A7BD-0149919FA7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230697D-547B-4269-A134-93308087BB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B5C0C-B1D2-4646-ADAA-0B8EEFA78297}" type="datetimeFigureOut">
              <a:rPr lang="fr-FR" smtClean="0"/>
              <a:t>22/04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7F0B4EE-9F76-4BF2-A02E-23B165E861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B11FAC-0893-4488-BAB3-33475758DE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11A13-BAD2-4E27-A5E2-71A34A8A23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7876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04395" y="634701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517933" y="465706"/>
            <a:ext cx="7942576" cy="2055822"/>
            <a:chOff x="277788" y="299451"/>
            <a:chExt cx="6128933" cy="1619999"/>
          </a:xfrm>
        </p:grpSpPr>
        <p:graphicFrame>
          <p:nvGraphicFramePr>
            <p:cNvPr id="4" name="Obje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7634455"/>
                </p:ext>
              </p:extLst>
            </p:nvPr>
          </p:nvGraphicFramePr>
          <p:xfrm>
            <a:off x="1618577" y="299451"/>
            <a:ext cx="1202468" cy="1619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6" name="Prism 10" r:id="rId3" imgW="1865283" imgH="2512892" progId="Prism10.Document">
                    <p:embed/>
                  </p:oleObj>
                </mc:Choice>
                <mc:Fallback>
                  <p:oleObj name="Prism 10" r:id="rId3" imgW="1865283" imgH="2512892" progId="Prism10.Document">
                    <p:embed/>
                    <p:pic>
                      <p:nvPicPr>
                        <p:cNvPr id="70" name="Objet 69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18577" y="299451"/>
                          <a:ext cx="1202468" cy="1619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34806273"/>
                </p:ext>
              </p:extLst>
            </p:nvPr>
          </p:nvGraphicFramePr>
          <p:xfrm>
            <a:off x="2853557" y="299451"/>
            <a:ext cx="1202468" cy="1619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7" name="Prism 10" r:id="rId5" imgW="1865283" imgH="2512892" progId="Prism10.Document">
                    <p:embed/>
                  </p:oleObj>
                </mc:Choice>
                <mc:Fallback>
                  <p:oleObj name="Prism 10" r:id="rId5" imgW="1865283" imgH="2512892" progId="Prism10.Document">
                    <p:embed/>
                    <p:pic>
                      <p:nvPicPr>
                        <p:cNvPr id="71" name="Objet 7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853557" y="299451"/>
                          <a:ext cx="1202468" cy="1619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6500583"/>
                </p:ext>
              </p:extLst>
            </p:nvPr>
          </p:nvGraphicFramePr>
          <p:xfrm>
            <a:off x="4088537" y="299451"/>
            <a:ext cx="1144134" cy="1619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Prism 10" r:id="rId7" imgW="1775295" imgH="2512892" progId="Prism10.Document">
                    <p:embed/>
                  </p:oleObj>
                </mc:Choice>
                <mc:Fallback>
                  <p:oleObj name="Prism 10" r:id="rId7" imgW="1775295" imgH="2512892" progId="Prism10.Document">
                    <p:embed/>
                    <p:pic>
                      <p:nvPicPr>
                        <p:cNvPr id="72" name="Objet 7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088537" y="299451"/>
                          <a:ext cx="1144134" cy="1619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93084069"/>
                </p:ext>
              </p:extLst>
            </p:nvPr>
          </p:nvGraphicFramePr>
          <p:xfrm>
            <a:off x="5262587" y="299451"/>
            <a:ext cx="1144134" cy="1619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Prism 10" r:id="rId9" imgW="1775295" imgH="2512892" progId="Prism10.Document">
                    <p:embed/>
                  </p:oleObj>
                </mc:Choice>
                <mc:Fallback>
                  <p:oleObj name="Prism 10" r:id="rId9" imgW="1775295" imgH="2512892" progId="Prism10.Document">
                    <p:embed/>
                    <p:pic>
                      <p:nvPicPr>
                        <p:cNvPr id="73" name="Objet 72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262587" y="299451"/>
                          <a:ext cx="1144134" cy="1619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6896029"/>
                </p:ext>
              </p:extLst>
            </p:nvPr>
          </p:nvGraphicFramePr>
          <p:xfrm>
            <a:off x="277788" y="299451"/>
            <a:ext cx="1303777" cy="1619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name="Prism 10" r:id="rId11" imgW="2022223" imgH="2512892" progId="Prism10.Document">
                    <p:embed/>
                  </p:oleObj>
                </mc:Choice>
                <mc:Fallback>
                  <p:oleObj name="Prism 10" r:id="rId11" imgW="2022223" imgH="2512892" progId="Prism10.Document">
                    <p:embed/>
                    <p:pic>
                      <p:nvPicPr>
                        <p:cNvPr id="76" name="Objet 75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77788" y="299451"/>
                          <a:ext cx="1303777" cy="1619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98651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/>
          <a:srcRect t="69624"/>
          <a:stretch/>
        </p:blipFill>
        <p:spPr>
          <a:xfrm>
            <a:off x="369277" y="257908"/>
            <a:ext cx="11564815" cy="1580821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6766560" y="257908"/>
            <a:ext cx="3230880" cy="143881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4592" y="2761541"/>
            <a:ext cx="10982960" cy="2060768"/>
          </a:xfrm>
          <a:prstGeom prst="rect">
            <a:avLst/>
          </a:prstGeom>
          <a:ln>
            <a:noFill/>
          </a:ln>
        </p:spPr>
      </p:pic>
      <p:cxnSp>
        <p:nvCxnSpPr>
          <p:cNvPr id="7" name="Connecteur droit 6"/>
          <p:cNvCxnSpPr/>
          <p:nvPr/>
        </p:nvCxnSpPr>
        <p:spPr>
          <a:xfrm flipV="1">
            <a:off x="984592" y="1696720"/>
            <a:ext cx="5781968" cy="103697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 flipH="1" flipV="1">
            <a:off x="9997440" y="1696720"/>
            <a:ext cx="1970112" cy="1064822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54928" y="3523600"/>
            <a:ext cx="92685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dex case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54928" y="4009054"/>
            <a:ext cx="6286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ther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54928" y="4494508"/>
            <a:ext cx="66236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ther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269072" y="3482340"/>
            <a:ext cx="899160" cy="793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1261452" y="3979534"/>
            <a:ext cx="899160" cy="793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/>
          <p:cNvSpPr/>
          <p:nvPr/>
        </p:nvSpPr>
        <p:spPr>
          <a:xfrm>
            <a:off x="1261452" y="4415148"/>
            <a:ext cx="899160" cy="793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ZoneTexte 21"/>
          <p:cNvSpPr txBox="1"/>
          <p:nvPr/>
        </p:nvSpPr>
        <p:spPr>
          <a:xfrm>
            <a:off x="204395" y="634701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202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5A6B4259-C7AA-4BA9-B502-543FACE098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795" y="463608"/>
            <a:ext cx="12010126" cy="53275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F6B2172-A720-4AFE-AD13-9B2CB1A19015}"/>
              </a:ext>
            </a:extLst>
          </p:cNvPr>
          <p:cNvSpPr/>
          <p:nvPr/>
        </p:nvSpPr>
        <p:spPr>
          <a:xfrm>
            <a:off x="374469" y="1280161"/>
            <a:ext cx="792480" cy="2525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dirty="0">
                <a:solidFill>
                  <a:schemeClr val="tx1"/>
                </a:solidFill>
              </a:rPr>
              <a:t>95 variant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5BC4874-DC99-48EC-BE1C-393C4386EE4F}"/>
              </a:ext>
            </a:extLst>
          </p:cNvPr>
          <p:cNvSpPr/>
          <p:nvPr/>
        </p:nvSpPr>
        <p:spPr>
          <a:xfrm rot="16200000">
            <a:off x="108859" y="4781006"/>
            <a:ext cx="1576251" cy="2525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000" b="1" dirty="0">
                <a:solidFill>
                  <a:schemeClr val="tx1"/>
                </a:solidFill>
              </a:rPr>
              <a:t>SAMD9 </a:t>
            </a:r>
            <a:r>
              <a:rPr lang="en-CA" sz="1000" b="1" dirty="0">
                <a:solidFill>
                  <a:schemeClr val="tx1"/>
                </a:solidFill>
              </a:rPr>
              <a:t>protein domain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204395" y="634701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9161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6ACCE39-F149-48A0-B9B7-BF657BF582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6954"/>
            <a:ext cx="12192000" cy="53293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1F7B60F-6521-4C02-B251-53C6B0557B08}"/>
              </a:ext>
            </a:extLst>
          </p:cNvPr>
          <p:cNvSpPr/>
          <p:nvPr/>
        </p:nvSpPr>
        <p:spPr>
          <a:xfrm rot="16200000">
            <a:off x="213363" y="4807132"/>
            <a:ext cx="1576251" cy="2525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000" b="1">
                <a:solidFill>
                  <a:schemeClr val="tx1"/>
                </a:solidFill>
              </a:rPr>
              <a:t>SAMD9L </a:t>
            </a:r>
            <a:r>
              <a:rPr lang="en-CA" sz="1000" b="1">
                <a:solidFill>
                  <a:schemeClr val="tx1"/>
                </a:solidFill>
              </a:rPr>
              <a:t>protein </a:t>
            </a:r>
            <a:r>
              <a:rPr lang="en-CA" sz="1000" b="1" dirty="0">
                <a:solidFill>
                  <a:schemeClr val="tx1"/>
                </a:solidFill>
              </a:rPr>
              <a:t>domain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204395" y="634701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16305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24</Words>
  <Application>Microsoft Office PowerPoint</Application>
  <PresentationFormat>Grand écran</PresentationFormat>
  <Paragraphs>10</Paragraphs>
  <Slides>4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hème Office</vt:lpstr>
      <vt:lpstr>Prism 10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MMUNO-RG.02</dc:creator>
  <cp:lastModifiedBy>Mathieu Fusaro</cp:lastModifiedBy>
  <cp:revision>7</cp:revision>
  <dcterms:created xsi:type="dcterms:W3CDTF">2026-02-25T11:54:06Z</dcterms:created>
  <dcterms:modified xsi:type="dcterms:W3CDTF">2026-04-22T19:54:55Z</dcterms:modified>
</cp:coreProperties>
</file>